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9158"/>
    <p:restoredTop sz="86441"/>
  </p:normalViewPr>
  <p:slideViewPr>
    <p:cSldViewPr snapToGrid="0">
      <p:cViewPr varScale="1">
        <p:scale>
          <a:sx n="63" d="100"/>
          <a:sy n="63" d="100"/>
        </p:scale>
        <p:origin x="216" y="88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4CEBDF-E193-2143-80D3-75DCED927B3A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DC17EA-A980-D444-A665-485AEC2A135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0155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52E26D6-4D23-4820-BF1D-372358CD12F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3639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EC5B8AC-12E0-FDF6-A177-4D2B80C677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425EEAB-1CA9-0FC8-79F1-8049346CB9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B935ECA-D2B4-887E-72A5-C4ED6FE55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F35DF91-B0C5-D654-D860-F0D269895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0FCCA22-A784-DBDC-6FAF-9452330B6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6238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F59499-B06F-3974-8F7F-FFF165713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ECFBE7E-8817-4F23-353E-7B5F596E51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EADC6D2-C599-CE6C-4880-2181B8A8D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4D781C4-20CC-13B9-E036-E093A6F40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50E3D06-04E3-8EAD-41AE-3D0420A28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7409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1CF6B26-9A7F-7C5C-CCE0-C02BD0A49D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59A50AD-5279-8932-37CB-069E026F5C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A92613A-13DE-0B12-550C-997921C9A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C3E5EC0-CEAC-04EF-FFF8-32863F814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E7ADC52-233F-5598-BD84-B5B2AF9FC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374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732B379-E8A0-2A73-86A4-3D6D509D6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FF58804-F904-EEB0-1BFB-57F4FBE436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31C0D77-D173-82B9-98CC-4F219AC5C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B7846E8-705C-48C7-4C71-1F71E39ED3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53BB3C3-42E3-63AE-5B8F-4C410F4A1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9089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838441E-50A5-7D9C-7832-E006EA1A1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1086A2B-1410-5BFF-EFE4-1E6191218E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87A6520-F53E-2EC7-A349-87ECBA0CE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B294540-FDFA-D95D-0A59-92BA07A87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E258D93-E310-7338-11B9-6E263F1D8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5033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B0D8A6-1584-54B2-AEB8-7711B8EC6D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7AF2C4E-997A-87B7-1F19-21E3E47E8B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D175E99-384F-2A9F-7DC4-D0C1755715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A56AE7A-1ADD-29F7-111F-4F6036DA8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A62BA7D-E90B-500C-DCF2-C0AF89964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C1C4F7D-C0DC-0DD1-0F0F-506D8C088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411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DFC1342-7B10-984C-F854-15AB72A346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859F2D4-6C7A-B6BE-AD2F-B84B91E106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7857843-396A-1E85-19CA-94A7C2632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EEE0F22B-477E-3CC9-0A5B-FA245738DB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04F21F5-3B76-2EC9-46C6-201B711103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63C97C1-727A-E34A-5A87-5D9FDEA92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1F82EBC7-BA3B-EA0C-16D7-75BDC4840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F49872C-EF2F-190F-46B8-711395A4E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5640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D3A61C6-C87B-5DBA-49AC-F6C15C645A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2E35B6D-5CFC-F4FA-9349-5BA1B3D32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693A089-983A-FD98-4B26-1C6CC8D57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055CA34-BEB6-AEE1-0B47-268ADA40A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1369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DEA89A55-43DA-8324-5B4B-2A6F72F0D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5FCD272-3715-51A9-7D96-BFB9B4504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7D0A3418-BD6C-2AE1-57F0-B92ADBD54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2131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184648-2F57-9721-E3ED-06386B413E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7D3F24D-08C3-F944-6393-D4DC5405C6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9684C54-CDE3-FAF9-F060-1C6C6D15A5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983074E-C1D9-F53F-2734-4A747F8BC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7CBC84E-0128-C61A-25B6-0425FA17D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6B7E709-C491-5CF3-DEF2-5F3F2F70B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7520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AEF1C53-750A-9D52-29C2-12941B3390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1030BC4-4799-3C9C-A0D8-9427A87404A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9B96DC3-8CC6-09F1-3EF0-63839AD53D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D18B081-B341-737A-F74E-782E86AD6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08274F8-8A31-4B9F-E015-EB52FB5F0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590C868-9F84-858D-5F6F-1140BB4DC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655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843BFD3-7B7C-6A60-B1C6-FC446BFF4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DEC4D99-62F7-06CC-0FF1-859F9D7071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EB314BB-7354-BF22-50BD-466D020693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FC001-531B-D640-8A70-136F0938E983}" type="datetimeFigureOut">
              <a:rPr lang="de-DE" smtClean="0"/>
              <a:t>07.08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7DDDD45-98D2-957A-9189-97DF374933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37CA369-4979-3D7D-DE8E-F8AEF73BAA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7016A-14BB-FA49-A01C-38ED266BC46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1810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Bild 2">
            <a:extLst>
              <a:ext uri="{FF2B5EF4-FFF2-40B4-BE49-F238E27FC236}">
                <a16:creationId xmlns:a16="http://schemas.microsoft.com/office/drawing/2014/main" id="{2550A3E9-D225-5AF9-1AE1-C1ABEC3A49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59" r="23855" b="5823"/>
          <a:stretch>
            <a:fillRect/>
          </a:stretch>
        </p:blipFill>
        <p:spPr bwMode="auto">
          <a:xfrm>
            <a:off x="156838" y="2124335"/>
            <a:ext cx="5503496" cy="300082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EA2A0B00-F72E-E8D6-9331-94FF4416A19B}"/>
              </a:ext>
            </a:extLst>
          </p:cNvPr>
          <p:cNvSpPr txBox="1"/>
          <p:nvPr/>
        </p:nvSpPr>
        <p:spPr>
          <a:xfrm>
            <a:off x="-12948" y="5659848"/>
            <a:ext cx="139381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Non-CTO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TO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C75B0E92-FFB3-C702-51F3-C115E83DE56F}"/>
              </a:ext>
            </a:extLst>
          </p:cNvPr>
          <p:cNvSpPr txBox="1"/>
          <p:nvPr/>
        </p:nvSpPr>
        <p:spPr>
          <a:xfrm rot="16200000">
            <a:off x="-377232" y="3213372"/>
            <a:ext cx="1144865" cy="292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03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</a:p>
        </p:txBody>
      </p:sp>
      <p:graphicFrame>
        <p:nvGraphicFramePr>
          <p:cNvPr id="7" name="Tabelle 6">
            <a:extLst>
              <a:ext uri="{FF2B5EF4-FFF2-40B4-BE49-F238E27FC236}">
                <a16:creationId xmlns:a16="http://schemas.microsoft.com/office/drawing/2014/main" id="{4E654658-C7B9-2C00-243F-7A86E828F5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7334489"/>
              </p:ext>
            </p:extLst>
          </p:nvPr>
        </p:nvGraphicFramePr>
        <p:xfrm>
          <a:off x="773834" y="4314137"/>
          <a:ext cx="4937510" cy="49593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442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06152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1706937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</a:tblGrid>
              <a:tr h="296463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5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-cause mortality,</a:t>
                      </a:r>
                      <a:r>
                        <a:rPr lang="en-GB" sz="105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n </a:t>
                      </a:r>
                      <a:r>
                        <a:rPr lang="en-GB" sz="105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69086" marR="6908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-CTO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10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5; 74%)</a:t>
                      </a:r>
                    </a:p>
                  </a:txBody>
                  <a:tcPr marL="69086" marR="6908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78E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TO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10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10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33; 26%)</a:t>
                      </a:r>
                    </a:p>
                  </a:txBody>
                  <a:tcPr marL="69086" marR="6908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5002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139513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 </a:t>
                      </a:r>
                      <a:r>
                        <a:rPr lang="de-DE" sz="10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6)</a:t>
                      </a:r>
                    </a:p>
                  </a:txBody>
                  <a:tcPr marL="69086" marR="6908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7 </a:t>
                      </a:r>
                      <a:r>
                        <a:rPr lang="de-DE" sz="10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82)</a:t>
                      </a: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9086" marR="6908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E01CABE5-44F8-5DCD-B686-0F8D17058821}"/>
              </a:ext>
            </a:extLst>
          </p:cNvPr>
          <p:cNvSpPr txBox="1"/>
          <p:nvPr/>
        </p:nvSpPr>
        <p:spPr>
          <a:xfrm>
            <a:off x="596405" y="5812719"/>
            <a:ext cx="78446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AFC3AC0-69A6-CC3A-FAFB-EB9ACBC91E89}"/>
              </a:ext>
            </a:extLst>
          </p:cNvPr>
          <p:cNvSpPr txBox="1"/>
          <p:nvPr/>
        </p:nvSpPr>
        <p:spPr>
          <a:xfrm>
            <a:off x="3256877" y="1816311"/>
            <a:ext cx="2472281" cy="435976"/>
          </a:xfrm>
          <a:prstGeom prst="rect">
            <a:avLst/>
          </a:prstGeom>
          <a:noFill/>
        </p:spPr>
        <p:txBody>
          <a:bodyPr wrap="square" lIns="96481" tIns="48240" rIns="96481" bIns="48240" rtlCol="0">
            <a:spAutoFit/>
          </a:bodyPr>
          <a:lstStyle/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Log rank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= 0.016</a:t>
            </a:r>
          </a:p>
          <a:p>
            <a:pPr algn="r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HR 1.773; 95% CI 1.114-2.823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F85EBE1-4D5A-2C47-4C95-D550C45ECC98}"/>
              </a:ext>
            </a:extLst>
          </p:cNvPr>
          <p:cNvSpPr txBox="1"/>
          <p:nvPr/>
        </p:nvSpPr>
        <p:spPr>
          <a:xfrm>
            <a:off x="2544337" y="5089115"/>
            <a:ext cx="1478879" cy="297936"/>
          </a:xfrm>
          <a:prstGeom prst="rect">
            <a:avLst/>
          </a:prstGeom>
          <a:noFill/>
        </p:spPr>
        <p:txBody>
          <a:bodyPr wrap="none" lIns="96494" tIns="48245" rIns="96494" bIns="48245" rtlCol="0">
            <a:spAutoFit/>
          </a:bodyPr>
          <a:lstStyle/>
          <a:p>
            <a:r>
              <a:rPr lang="en-GB" sz="1303" b="1" dirty="0">
                <a:latin typeface="Arial" panose="020B0604020202020204" pitchFamily="34" charset="0"/>
                <a:cs typeface="Arial" panose="020B0604020202020204" pitchFamily="34" charset="0"/>
              </a:rPr>
              <a:t>Days of survival</a:t>
            </a:r>
          </a:p>
        </p:txBody>
      </p: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09205E51-399A-AAAD-61BD-52353FE7649F}"/>
              </a:ext>
            </a:extLst>
          </p:cNvPr>
          <p:cNvCxnSpPr>
            <a:cxnSpLocks/>
          </p:cNvCxnSpPr>
          <p:nvPr/>
        </p:nvCxnSpPr>
        <p:spPr>
          <a:xfrm>
            <a:off x="156838" y="5555607"/>
            <a:ext cx="11893200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feld 23">
            <a:extLst>
              <a:ext uri="{FF2B5EF4-FFF2-40B4-BE49-F238E27FC236}">
                <a16:creationId xmlns:a16="http://schemas.microsoft.com/office/drawing/2014/main" id="{45E954F3-DD57-70C2-4767-596D9FC9CB46}"/>
              </a:ext>
            </a:extLst>
          </p:cNvPr>
          <p:cNvSpPr txBox="1"/>
          <p:nvPr/>
        </p:nvSpPr>
        <p:spPr>
          <a:xfrm>
            <a:off x="2378320" y="5810236"/>
            <a:ext cx="7844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69C0D11F-7571-0CA3-B99F-5303DB4E8D8B}"/>
              </a:ext>
            </a:extLst>
          </p:cNvPr>
          <p:cNvSpPr txBox="1"/>
          <p:nvPr/>
        </p:nvSpPr>
        <p:spPr>
          <a:xfrm>
            <a:off x="3269277" y="5804092"/>
            <a:ext cx="78446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35793B30-5F48-FF98-83A4-3D86B98F4EF0}"/>
              </a:ext>
            </a:extLst>
          </p:cNvPr>
          <p:cNvSpPr txBox="1"/>
          <p:nvPr/>
        </p:nvSpPr>
        <p:spPr>
          <a:xfrm>
            <a:off x="5051191" y="5810236"/>
            <a:ext cx="78446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graphicFrame>
        <p:nvGraphicFramePr>
          <p:cNvPr id="12" name="Tabelle 67">
            <a:extLst>
              <a:ext uri="{FF2B5EF4-FFF2-40B4-BE49-F238E27FC236}">
                <a16:creationId xmlns:a16="http://schemas.microsoft.com/office/drawing/2014/main" id="{703D540C-F894-E133-0ABA-03CBEFC637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9708748"/>
              </p:ext>
            </p:extLst>
          </p:nvPr>
        </p:nvGraphicFramePr>
        <p:xfrm>
          <a:off x="773834" y="875710"/>
          <a:ext cx="2778498" cy="383822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2778498">
                  <a:extLst>
                    <a:ext uri="{9D8B030D-6E8A-4147-A177-3AD203B41FA5}">
                      <a16:colId xmlns:a16="http://schemas.microsoft.com/office/drawing/2014/main" val="2817053231"/>
                    </a:ext>
                  </a:extLst>
                </a:gridCol>
              </a:tblGrid>
              <a:tr h="383822">
                <a:tc>
                  <a:txBody>
                    <a:bodyPr/>
                    <a:lstStyle/>
                    <a:p>
                      <a:pPr algn="ctr"/>
                      <a:r>
                        <a:rPr lang="en-GB" sz="13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-cause mortality at 30 days</a:t>
                      </a:r>
                    </a:p>
                  </a:txBody>
                  <a:tcPr marL="181770" marR="181770" marT="90887" marB="90887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14415734"/>
                  </a:ext>
                </a:extLst>
              </a:tr>
            </a:tbl>
          </a:graphicData>
        </a:graphic>
      </p:graphicFrame>
      <p:sp>
        <p:nvSpPr>
          <p:cNvPr id="8" name="Eine Ecke des Rechtecks abrunden 7">
            <a:extLst>
              <a:ext uri="{FF2B5EF4-FFF2-40B4-BE49-F238E27FC236}">
                <a16:creationId xmlns:a16="http://schemas.microsoft.com/office/drawing/2014/main" id="{42F5F574-84FD-98C4-F7D9-E72F7596E647}"/>
              </a:ext>
            </a:extLst>
          </p:cNvPr>
          <p:cNvSpPr/>
          <p:nvPr/>
        </p:nvSpPr>
        <p:spPr>
          <a:xfrm>
            <a:off x="446550" y="1934727"/>
            <a:ext cx="299710" cy="2980266"/>
          </a:xfrm>
          <a:prstGeom prst="round1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BA019E4B-9B8C-9631-9386-47CAD6CE4DA2}"/>
              </a:ext>
            </a:extLst>
          </p:cNvPr>
          <p:cNvSpPr txBox="1"/>
          <p:nvPr/>
        </p:nvSpPr>
        <p:spPr>
          <a:xfrm>
            <a:off x="278670" y="2132078"/>
            <a:ext cx="474133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05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05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05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05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Bild 6">
            <a:extLst>
              <a:ext uri="{FF2B5EF4-FFF2-40B4-BE49-F238E27FC236}">
                <a16:creationId xmlns:a16="http://schemas.microsoft.com/office/drawing/2014/main" id="{E7134437-F8DE-86CA-53DC-3758FAB8BD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49" t="85311" b="6053"/>
          <a:stretch>
            <a:fillRect/>
          </a:stretch>
        </p:blipFill>
        <p:spPr bwMode="auto">
          <a:xfrm>
            <a:off x="547463" y="4822851"/>
            <a:ext cx="5318211" cy="29157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ADE74362-AEE9-8229-1A44-117FB500C02B}"/>
              </a:ext>
            </a:extLst>
          </p:cNvPr>
          <p:cNvSpPr txBox="1"/>
          <p:nvPr/>
        </p:nvSpPr>
        <p:spPr>
          <a:xfrm>
            <a:off x="1487362" y="5818772"/>
            <a:ext cx="78446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DF7E83DB-DA6F-7BC6-4A04-030853637CE6}"/>
              </a:ext>
            </a:extLst>
          </p:cNvPr>
          <p:cNvSpPr txBox="1"/>
          <p:nvPr/>
        </p:nvSpPr>
        <p:spPr>
          <a:xfrm>
            <a:off x="4160234" y="5804092"/>
            <a:ext cx="78446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1918735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Macintosh PowerPoint</Application>
  <PresentationFormat>Breitbild</PresentationFormat>
  <Paragraphs>44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ritz Schmidberger</dc:creator>
  <cp:lastModifiedBy>m.schmidberger00@gmail.com</cp:lastModifiedBy>
  <cp:revision>11</cp:revision>
  <dcterms:created xsi:type="dcterms:W3CDTF">2023-04-09T12:32:20Z</dcterms:created>
  <dcterms:modified xsi:type="dcterms:W3CDTF">2025-08-07T16:17:41Z</dcterms:modified>
</cp:coreProperties>
</file>